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584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38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69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935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914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302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688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157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039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3978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297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D71CA6-D63D-483B-96A1-6F5D085A5115}" type="datetimeFigureOut">
              <a:rPr lang="en-US" smtClean="0"/>
              <a:t>7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010EB-2C5D-4775-AC7A-62C7C0542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083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EF636A2-0E4E-4566-813F-F5E40B5EF222}"/>
              </a:ext>
            </a:extLst>
          </p:cNvPr>
          <p:cNvGraphicFramePr>
            <a:graphicFrameLocks noGrp="1"/>
          </p:cNvGraphicFramePr>
          <p:nvPr/>
        </p:nvGraphicFramePr>
        <p:xfrm>
          <a:off x="2682234" y="1538281"/>
          <a:ext cx="6481888" cy="2434569"/>
        </p:xfrm>
        <a:graphic>
          <a:graphicData uri="http://schemas.openxmlformats.org/drawingml/2006/table">
            <a:tbl>
              <a:tblPr/>
              <a:tblGrid>
                <a:gridCol w="841970">
                  <a:extLst>
                    <a:ext uri="{9D8B030D-6E8A-4147-A177-3AD203B41FA5}">
                      <a16:colId xmlns:a16="http://schemas.microsoft.com/office/drawing/2014/main" val="1706488509"/>
                    </a:ext>
                  </a:extLst>
                </a:gridCol>
                <a:gridCol w="1012293">
                  <a:extLst>
                    <a:ext uri="{9D8B030D-6E8A-4147-A177-3AD203B41FA5}">
                      <a16:colId xmlns:a16="http://schemas.microsoft.com/office/drawing/2014/main" val="3843328968"/>
                    </a:ext>
                  </a:extLst>
                </a:gridCol>
                <a:gridCol w="903833">
                  <a:extLst>
                    <a:ext uri="{9D8B030D-6E8A-4147-A177-3AD203B41FA5}">
                      <a16:colId xmlns:a16="http://schemas.microsoft.com/office/drawing/2014/main" val="2952659103"/>
                    </a:ext>
                  </a:extLst>
                </a:gridCol>
                <a:gridCol w="903833">
                  <a:extLst>
                    <a:ext uri="{9D8B030D-6E8A-4147-A177-3AD203B41FA5}">
                      <a16:colId xmlns:a16="http://schemas.microsoft.com/office/drawing/2014/main" val="1165911079"/>
                    </a:ext>
                  </a:extLst>
                </a:gridCol>
                <a:gridCol w="1012293">
                  <a:extLst>
                    <a:ext uri="{9D8B030D-6E8A-4147-A177-3AD203B41FA5}">
                      <a16:colId xmlns:a16="http://schemas.microsoft.com/office/drawing/2014/main" val="3419780689"/>
                    </a:ext>
                  </a:extLst>
                </a:gridCol>
                <a:gridCol w="903833">
                  <a:extLst>
                    <a:ext uri="{9D8B030D-6E8A-4147-A177-3AD203B41FA5}">
                      <a16:colId xmlns:a16="http://schemas.microsoft.com/office/drawing/2014/main" val="3791257202"/>
                    </a:ext>
                  </a:extLst>
                </a:gridCol>
                <a:gridCol w="903833">
                  <a:extLst>
                    <a:ext uri="{9D8B030D-6E8A-4147-A177-3AD203B41FA5}">
                      <a16:colId xmlns:a16="http://schemas.microsoft.com/office/drawing/2014/main" val="1848175479"/>
                    </a:ext>
                  </a:extLst>
                </a:gridCol>
              </a:tblGrid>
              <a:tr h="264860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-free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-bearing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3038269"/>
                  </a:ext>
                </a:extLst>
              </a:tr>
              <a:tr h="37454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gan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 Treated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FA 2 mg/kg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FA 4 mg/kg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 Treated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FA 2 mg/kg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FA 4 mg/kg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826360"/>
                  </a:ext>
                </a:extLst>
              </a:tr>
              <a:tr h="2550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7 ± 1.84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98 ± 1.53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46 ± 0.75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40 ± 1.36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.79 ± 1.3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34 ± 1.6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7652514"/>
                  </a:ext>
                </a:extLst>
              </a:tr>
              <a:tr h="2550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s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3 ± 0.59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8 ± 0.54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2 ± 0.66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2 ± 0.70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24 ± 0.7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1 ± 0.7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48715"/>
                  </a:ext>
                </a:extLst>
              </a:tr>
              <a:tr h="2550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06 ± 0.72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34 ± 5.60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.56 ± 5.32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97 ± 4.52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04 ± 10.04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81 ± 3.15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4453596"/>
                  </a:ext>
                </a:extLst>
              </a:tr>
              <a:tr h="2648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 (L)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5 ± 0.23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3 ± 0.63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6 ± 0.38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1 ± 0.61</a:t>
                      </a:r>
                    </a:p>
                  </a:txBody>
                  <a:tcPr marL="4763" marR="4763" marT="4763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37 ± 0.43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5 ± 0.95</a:t>
                      </a:r>
                    </a:p>
                  </a:txBody>
                  <a:tcPr marL="4763" marR="4763" marT="476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2417793"/>
                  </a:ext>
                </a:extLst>
              </a:tr>
              <a:tr h="255051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s = mg Organ / g I.B.W.</a:t>
                      </a: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6599770"/>
                  </a:ext>
                </a:extLst>
              </a:tr>
              <a:tr h="25505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 ± S.D.</a:t>
                      </a: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5320017"/>
                  </a:ext>
                </a:extLst>
              </a:tr>
              <a:tr h="255051"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763" marR="4763" marT="476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115729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C265C9DD-59D4-4547-8BD6-DE0FABEFF67D}"/>
              </a:ext>
            </a:extLst>
          </p:cNvPr>
          <p:cNvSpPr txBox="1"/>
          <p:nvPr/>
        </p:nvSpPr>
        <p:spPr>
          <a:xfrm>
            <a:off x="8796799" y="6037622"/>
            <a:ext cx="1825436" cy="284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5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</a:p>
        </p:txBody>
      </p:sp>
    </p:spTree>
    <p:extLst>
      <p:ext uri="{BB962C8B-B14F-4D97-AF65-F5344CB8AC3E}">
        <p14:creationId xmlns:p14="http://schemas.microsoft.com/office/powerpoint/2010/main" val="1088354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Office PowerPoint</Application>
  <PresentationFormat>Widescreen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chn off30</cp:lastModifiedBy>
  <cp:revision>2</cp:revision>
  <dcterms:created xsi:type="dcterms:W3CDTF">2020-07-16T13:25:53Z</dcterms:created>
  <dcterms:modified xsi:type="dcterms:W3CDTF">2020-07-19T03:42:15Z</dcterms:modified>
</cp:coreProperties>
</file>